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56" r:id="rId4"/>
    <p:sldId id="260" r:id="rId5"/>
    <p:sldId id="257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576" y="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4677-8AC7-4F24-86D8-6E521151CABF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ACEC0-3CA8-4699-A011-1CF7369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760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4677-8AC7-4F24-86D8-6E521151CABF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ACEC0-3CA8-4699-A011-1CF7369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331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4677-8AC7-4F24-86D8-6E521151CABF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ACEC0-3CA8-4699-A011-1CF7369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4248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4677-8AC7-4F24-86D8-6E521151CABF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ACEC0-3CA8-4699-A011-1CF7369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920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4677-8AC7-4F24-86D8-6E521151CABF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ACEC0-3CA8-4699-A011-1CF7369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012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4677-8AC7-4F24-86D8-6E521151CABF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ACEC0-3CA8-4699-A011-1CF7369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632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4677-8AC7-4F24-86D8-6E521151CABF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ACEC0-3CA8-4699-A011-1CF7369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162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4677-8AC7-4F24-86D8-6E521151CABF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ACEC0-3CA8-4699-A011-1CF7369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299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4677-8AC7-4F24-86D8-6E521151CABF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ACEC0-3CA8-4699-A011-1CF7369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082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4677-8AC7-4F24-86D8-6E521151CABF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ACEC0-3CA8-4699-A011-1CF7369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675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0B4677-8AC7-4F24-86D8-6E521151CABF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ACEC0-3CA8-4699-A011-1CF7369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694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0B4677-8AC7-4F24-86D8-6E521151CABF}" type="datetimeFigureOut">
              <a:rPr lang="en-US" smtClean="0"/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0ACEC0-3CA8-4699-A011-1CF736966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834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28261" y="769491"/>
            <a:ext cx="8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File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600200" y="1491734"/>
            <a:ext cx="59330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 used in making </a:t>
            </a:r>
            <a:r>
              <a:rPr lang="en-US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KASII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NAi constructs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8929653"/>
              </p:ext>
            </p:extLst>
          </p:nvPr>
        </p:nvGraphicFramePr>
        <p:xfrm>
          <a:off x="1447800" y="2514597"/>
          <a:ext cx="6477000" cy="3048002"/>
        </p:xfrm>
        <a:graphic>
          <a:graphicData uri="http://schemas.openxmlformats.org/drawingml/2006/table">
            <a:tbl>
              <a:tblPr firstRow="1" firstCol="1" bandRow="1"/>
              <a:tblGrid>
                <a:gridCol w="1655775"/>
                <a:gridCol w="4821225"/>
              </a:tblGrid>
              <a:tr h="152400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Times New Roman" panose="02020603050405020304" pitchFamily="18" charset="0"/>
                          <a:ea typeface="SimSun"/>
                          <a:cs typeface="Times New Roman" panose="02020603050405020304" pitchFamily="18" charset="0"/>
                        </a:rPr>
                        <a:t>169 </a:t>
                      </a:r>
                      <a:r>
                        <a:rPr lang="en-US" sz="1400" dirty="0" err="1">
                          <a:effectLst/>
                          <a:latin typeface="Times New Roman" panose="02020603050405020304" pitchFamily="18" charset="0"/>
                          <a:ea typeface="SimSun"/>
                          <a:cs typeface="Times New Roman" panose="02020603050405020304" pitchFamily="18" charset="0"/>
                        </a:rPr>
                        <a:t>bp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SimSun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400" dirty="0" smtClean="0">
                          <a:effectLst/>
                          <a:latin typeface="Times New Roman" panose="02020603050405020304" pitchFamily="18" charset="0"/>
                          <a:ea typeface="SimSun"/>
                          <a:cs typeface="Times New Roman" panose="02020603050405020304" pitchFamily="18" charset="0"/>
                        </a:rPr>
                        <a:t>5’ UTR sequence 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SimSun"/>
                          <a:cs typeface="Times New Roman" panose="02020603050405020304" pitchFamily="18" charset="0"/>
                        </a:rPr>
                        <a:t>for </a:t>
                      </a:r>
                      <a:r>
                        <a:rPr lang="en-US" sz="1400" i="1" dirty="0">
                          <a:effectLst/>
                          <a:latin typeface="Times New Roman" panose="02020603050405020304" pitchFamily="18" charset="0"/>
                          <a:ea typeface="SimSun"/>
                          <a:cs typeface="Times New Roman" panose="02020603050405020304" pitchFamily="18" charset="0"/>
                        </a:rPr>
                        <a:t>RNAi-1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SimSu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TTTTACGCATCGAAGGCTCTCTGCACGCCTCCTGAAAGAGAGAGAGAGAGAGAAGGAGAGAGAGATCATCACAGATCGATTCTCTCTTAAATCTCTCGTGAATCCCATTTCCCCTTCCGCTAGATTCTCTCTTCACTCATTTCTCGCTTTCTCTCCTTTTGTTCTCTCT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SimSu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2400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SimSun"/>
                          <a:cs typeface="Times New Roman" panose="02020603050405020304" pitchFamily="18" charset="0"/>
                        </a:rPr>
                        <a:t>194 </a:t>
                      </a:r>
                      <a:r>
                        <a:rPr lang="en-US" sz="1400" dirty="0" err="1">
                          <a:effectLst/>
                          <a:latin typeface="Times New Roman" panose="02020603050405020304" pitchFamily="18" charset="0"/>
                          <a:ea typeface="SimSun"/>
                          <a:cs typeface="Times New Roman" panose="02020603050405020304" pitchFamily="18" charset="0"/>
                        </a:rPr>
                        <a:t>bp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SimSun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400" dirty="0" smtClean="0">
                          <a:effectLst/>
                          <a:latin typeface="Times New Roman" panose="02020603050405020304" pitchFamily="18" charset="0"/>
                          <a:ea typeface="SimSun"/>
                          <a:cs typeface="Times New Roman" panose="02020603050405020304" pitchFamily="18" charset="0"/>
                        </a:rPr>
                        <a:t>coding sequence 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SimSun"/>
                          <a:cs typeface="Times New Roman" panose="02020603050405020304" pitchFamily="18" charset="0"/>
                        </a:rPr>
                        <a:t>for </a:t>
                      </a:r>
                      <a:r>
                        <a:rPr lang="en-US" sz="1400" i="1" dirty="0">
                          <a:effectLst/>
                          <a:latin typeface="Times New Roman" panose="02020603050405020304" pitchFamily="18" charset="0"/>
                          <a:ea typeface="SimSun"/>
                          <a:cs typeface="Times New Roman" panose="02020603050405020304" pitchFamily="18" charset="0"/>
                        </a:rPr>
                        <a:t>RNAi-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SimSu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Times New Roman"/>
                          <a:cs typeface="Times New Roman" panose="02020603050405020304" pitchFamily="18" charset="0"/>
                        </a:rPr>
                        <a:t>AGGCGGAGATAGCCGCCAGGCTGCTGTCGCGCTTCAATCTGGTGGGCGGAGTCGGCGAAGGAGGCAGCTTACTAAATGCTCCTCTGCCTCTTCTCCTCCTCGATCCCCTTCCCCTCCTCCTACCATTCAAGCTCTTGTCTCTTCTTGTTTGGATTTTGGTCCTTGTACTCACTACTCCAACTCCAACTCCAACA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SimSun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309942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6038084"/>
              </p:ext>
            </p:extLst>
          </p:nvPr>
        </p:nvGraphicFramePr>
        <p:xfrm>
          <a:off x="1295400" y="1828801"/>
          <a:ext cx="6629401" cy="3201770"/>
        </p:xfrm>
        <a:graphic>
          <a:graphicData uri="http://schemas.openxmlformats.org/drawingml/2006/table">
            <a:tbl>
              <a:tblPr firstRow="1" firstCol="1" bandRow="1"/>
              <a:tblGrid>
                <a:gridCol w="1432500"/>
                <a:gridCol w="2204565"/>
                <a:gridCol w="2992336"/>
              </a:tblGrid>
              <a:tr h="27287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Gene detection</a:t>
                      </a:r>
                      <a:endParaRPr lang="en-US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Primer name</a:t>
                      </a:r>
                      <a:endParaRPr lang="en-US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Primer sequence</a:t>
                      </a:r>
                      <a:endParaRPr lang="en-US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2762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UcFATB1</a:t>
                      </a:r>
                      <a:endParaRPr lang="en-US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UcFATB1-F1</a:t>
                      </a:r>
                      <a:endParaRPr lang="en-US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5’-</a:t>
                      </a:r>
                      <a:r>
                        <a:rPr lang="en-US" sz="1100">
                          <a:effectLst/>
                          <a:latin typeface="Calibri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GAGAGAGTGCACGAGGGATA -3’</a:t>
                      </a:r>
                      <a:endParaRPr lang="en-US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84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UcFATB1-R1</a:t>
                      </a:r>
                      <a:endParaRPr lang="en-US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5’-</a:t>
                      </a:r>
                      <a:r>
                        <a:rPr lang="en-US" sz="1100">
                          <a:effectLst/>
                          <a:latin typeface="Calibri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CTGCAGGAATTCCCGATCTA -3’</a:t>
                      </a:r>
                      <a:endParaRPr lang="en-US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2762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 err="1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CsKASII</a:t>
                      </a:r>
                      <a:endParaRPr lang="en-US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CsKASII-F1uni</a:t>
                      </a:r>
                      <a:endParaRPr lang="en-US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5’- TTGCTACAAGGCAACAGTGG -3’</a:t>
                      </a:r>
                      <a:endParaRPr lang="en-US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84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CsKASII-R1uni</a:t>
                      </a:r>
                      <a:endParaRPr lang="en-US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5’ - AGACCTTCATCCCTCCCATT -3’</a:t>
                      </a:r>
                      <a:endParaRPr lang="en-US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8413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PP2A</a:t>
                      </a:r>
                      <a:endParaRPr lang="en-US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PP2A-qF1</a:t>
                      </a:r>
                      <a:endParaRPr lang="en-US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5’ –</a:t>
                      </a:r>
                      <a:r>
                        <a:rPr lang="en-US" sz="1100">
                          <a:effectLst/>
                          <a:latin typeface="Calibri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TAACGTCGCCAAAATGATGC -3’</a:t>
                      </a:r>
                      <a:endParaRPr lang="en-US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184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PP2A-qR1</a:t>
                      </a:r>
                      <a:endParaRPr lang="en-US" sz="110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5’ –</a:t>
                      </a:r>
                      <a:r>
                        <a:rPr lang="en-US" sz="1100" dirty="0">
                          <a:effectLst/>
                          <a:latin typeface="Calibri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 dirty="0">
                          <a:effectLst/>
                          <a:latin typeface="Times New Roman"/>
                          <a:ea typeface="SimSun"/>
                          <a:cs typeface="Times New Roman"/>
                        </a:rPr>
                        <a:t>GTTCTCCACAACCGATTGGT -3’</a:t>
                      </a:r>
                      <a:endParaRPr lang="en-US" sz="1100" dirty="0">
                        <a:effectLst/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209800" y="1033752"/>
            <a:ext cx="4002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s used for gene detection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89978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14607" y="2590800"/>
            <a:ext cx="4664075" cy="738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914400" y="1752600"/>
            <a:ext cx="986167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i -1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i-2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14400" y="3886199"/>
            <a:ext cx="7431843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KASII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NAi constructs. RNAi-1, </a:t>
            </a:r>
            <a:r>
              <a:rPr lang="el-GR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olin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 promoter; 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KASII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69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9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’UTR sequence of a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KASII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B: RNAi-2,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pin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pin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;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KASII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94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194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ding sequence of a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KASII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FAD2 intron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linker sequence used between two reversely oriented </a:t>
            </a: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NA fragments; 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paline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 gene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erminator. 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e details in the text.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2014607" y="1609627"/>
            <a:ext cx="4648200" cy="676373"/>
            <a:chOff x="1638300" y="1409308"/>
            <a:chExt cx="4648200" cy="676373"/>
          </a:xfrm>
        </p:grpSpPr>
        <p:sp>
          <p:nvSpPr>
            <p:cNvPr id="8" name="TextBox 7"/>
            <p:cNvSpPr txBox="1"/>
            <p:nvPr/>
          </p:nvSpPr>
          <p:spPr>
            <a:xfrm>
              <a:off x="1638300" y="1608995"/>
              <a:ext cx="7239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sz="12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as</a:t>
              </a:r>
              <a:endPara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ight Arrow 8"/>
            <p:cNvSpPr/>
            <p:nvPr/>
          </p:nvSpPr>
          <p:spPr>
            <a:xfrm>
              <a:off x="1676400" y="1409308"/>
              <a:ext cx="762000" cy="676373"/>
            </a:xfrm>
            <a:prstGeom prst="right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438400" y="1599414"/>
              <a:ext cx="1066800" cy="276999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KASII</a:t>
              </a:r>
              <a:r>
                <a:rPr lang="en-US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69</a:t>
              </a:r>
              <a:endPara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505200" y="1599414"/>
              <a:ext cx="1143000" cy="276999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FAD2 intron</a:t>
              </a:r>
              <a:endPara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0800000">
              <a:off x="4648200" y="1599415"/>
              <a:ext cx="1066800" cy="276999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i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KASII</a:t>
              </a:r>
              <a:r>
                <a:rPr lang="en-US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69</a:t>
              </a:r>
              <a:endPara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715000" y="1599414"/>
              <a:ext cx="571500" cy="276999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s</a:t>
              </a:r>
              <a:endPara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486825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28810" y="433721"/>
            <a:ext cx="8509000" cy="1128522"/>
            <a:chOff x="0" y="5619750"/>
            <a:chExt cx="8509000" cy="1128522"/>
          </a:xfrm>
        </p:grpSpPr>
        <p:grpSp>
          <p:nvGrpSpPr>
            <p:cNvPr id="4" name="Group 3"/>
            <p:cNvGrpSpPr/>
            <p:nvPr/>
          </p:nvGrpSpPr>
          <p:grpSpPr>
            <a:xfrm>
              <a:off x="0" y="5619750"/>
              <a:ext cx="8509000" cy="1128522"/>
              <a:chOff x="-154465" y="5632450"/>
              <a:chExt cx="8509000" cy="1128522"/>
            </a:xfrm>
          </p:grpSpPr>
          <p:sp>
            <p:nvSpPr>
              <p:cNvPr id="8" name="TextBox 7"/>
              <p:cNvSpPr txBox="1"/>
              <p:nvPr/>
            </p:nvSpPr>
            <p:spPr>
              <a:xfrm>
                <a:off x="4632403" y="6378448"/>
                <a:ext cx="1847850" cy="381000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  <a:sym typeface="Wingdings" panose="05000000000000000000" pitchFamily="2" charset="2"/>
                  </a:rPr>
                  <a:t>UcFATB1</a:t>
                </a:r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469618" y="6378448"/>
                <a:ext cx="990600" cy="381000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apin</a:t>
                </a:r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460500" y="6376924"/>
                <a:ext cx="1511300" cy="384048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  <a:sym typeface="Wingdings" panose="05000000000000000000" pitchFamily="2" charset="2"/>
                  </a:rPr>
                  <a:t></a:t>
                </a:r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Cherry</a:t>
                </a:r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2971800" y="6378448"/>
                <a:ext cx="647276" cy="381000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S </a:t>
                </a:r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7821135" y="6376924"/>
                <a:ext cx="533400" cy="384048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B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3960335" y="6376924"/>
                <a:ext cx="672068" cy="384048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S</a:t>
                </a:r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-154465" y="6378448"/>
                <a:ext cx="533400" cy="381000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</a:t>
                </a:r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683735" y="6376924"/>
                <a:ext cx="776765" cy="384048"/>
              </a:xfrm>
              <a:prstGeom prst="rect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S</a:t>
                </a:r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305769" y="5632450"/>
                <a:ext cx="1111766" cy="369332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r>
                  <a:rPr lang="en-US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mH</a:t>
                </a:r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I</a:t>
                </a:r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7" name="Straight Arrow Connector 16"/>
              <p:cNvCxnSpPr/>
              <p:nvPr/>
            </p:nvCxnSpPr>
            <p:spPr>
              <a:xfrm>
                <a:off x="3774637" y="6000750"/>
                <a:ext cx="10815" cy="381000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  <p:sp>
            <p:nvSpPr>
              <p:cNvPr id="18" name="TextBox 17"/>
              <p:cNvSpPr txBox="1"/>
              <p:nvPr/>
            </p:nvSpPr>
            <p:spPr>
              <a:xfrm>
                <a:off x="4773135" y="5880100"/>
                <a:ext cx="990600" cy="381000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be</a:t>
                </a:r>
                <a:endPara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9" name="Straight Connector 18"/>
              <p:cNvCxnSpPr/>
              <p:nvPr/>
            </p:nvCxnSpPr>
            <p:spPr>
              <a:xfrm>
                <a:off x="4967765" y="6306582"/>
                <a:ext cx="643570" cy="0"/>
              </a:xfrm>
              <a:prstGeom prst="line">
                <a:avLst/>
              </a:prstGeom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</p:cxnSp>
        </p:grpSp>
        <p:cxnSp>
          <p:nvCxnSpPr>
            <p:cNvPr id="5" name="Straight Connector 4"/>
            <p:cNvCxnSpPr>
              <a:stCxn id="14" idx="3"/>
              <a:endCxn id="15" idx="1"/>
            </p:cNvCxnSpPr>
            <p:nvPr/>
          </p:nvCxnSpPr>
          <p:spPr>
            <a:xfrm>
              <a:off x="533400" y="6556248"/>
              <a:ext cx="304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>
              <a:stCxn id="11" idx="3"/>
              <a:endCxn id="13" idx="1"/>
            </p:cNvCxnSpPr>
            <p:nvPr/>
          </p:nvCxnSpPr>
          <p:spPr>
            <a:xfrm>
              <a:off x="3773541" y="6556248"/>
              <a:ext cx="3412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>
              <a:stCxn id="9" idx="3"/>
              <a:endCxn id="12" idx="1"/>
            </p:cNvCxnSpPr>
            <p:nvPr/>
          </p:nvCxnSpPr>
          <p:spPr>
            <a:xfrm>
              <a:off x="7614683" y="6556248"/>
              <a:ext cx="3609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TextBox 28"/>
          <p:cNvSpPr txBox="1"/>
          <p:nvPr/>
        </p:nvSpPr>
        <p:spPr>
          <a:xfrm>
            <a:off x="3889044" y="2438400"/>
            <a:ext cx="5111607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uthern analysis. 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-DNA section of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cFATB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expression construct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B: Right Border;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pi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pi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;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cFATB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California bay 12:0-acyl-carrier protein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ioesterase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(NCBI GI:170555); 35S: cauliflower mosaic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ru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S promoter;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erry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uorescence gene;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Left Border.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mHI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used for genomic DNA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gestion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 probe used in Southern was a fragment of 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cFATB1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ding sequence. B. Southern blot analysis of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cFATB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genic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s (No. 4, 12 an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non-transgenic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elina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lant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 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30" name="TextBox 29"/>
          <p:cNvSpPr txBox="1"/>
          <p:nvPr/>
        </p:nvSpPr>
        <p:spPr>
          <a:xfrm>
            <a:off x="449504" y="312039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.</a:t>
            </a:r>
            <a:endParaRPr lang="en-US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449504" y="1869181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.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0643" y="2238513"/>
            <a:ext cx="3236913" cy="4365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642858" y="2792751"/>
            <a:ext cx="587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W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58544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0" y="1066800"/>
            <a:ext cx="4260850" cy="3041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990600" y="4267200"/>
            <a:ext cx="6976757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 of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KASII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 in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sKASII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NAi transformed and wild type lines. RNA was extracted from T</a:t>
            </a:r>
            <a:r>
              <a:rPr lang="en-US" sz="14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4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vidual immature seeds 15-20 days after pollination. Gene expression was measured by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PCR SYBR Green method and normalized to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P2A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. </a:t>
            </a:r>
            <a:endParaRPr lang="en-US" sz="1400" dirty="0" smtClean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4185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</TotalTime>
  <Words>345</Words>
  <Application>Microsoft Office PowerPoint</Application>
  <PresentationFormat>On-screen Show (4:3)</PresentationFormat>
  <Paragraphs>54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n Qu</dc:creator>
  <cp:lastModifiedBy>Ron Qu</cp:lastModifiedBy>
  <cp:revision>27</cp:revision>
  <dcterms:created xsi:type="dcterms:W3CDTF">2016-05-20T18:45:47Z</dcterms:created>
  <dcterms:modified xsi:type="dcterms:W3CDTF">2017-02-09T13:37:04Z</dcterms:modified>
</cp:coreProperties>
</file>